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8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565"/>
  </p:normalViewPr>
  <p:slideViewPr>
    <p:cSldViewPr snapToGrid="0" snapToObjects="1">
      <p:cViewPr varScale="1">
        <p:scale>
          <a:sx n="105" d="100"/>
          <a:sy n="105" d="100"/>
        </p:scale>
        <p:origin x="184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EB75024-0A39-2B4D-AC18-898B18B15E61}" type="datetimeFigureOut">
              <a:rPr kumimoji="1" lang="ja-JP" altLang="en-US" smtClean="0"/>
              <a:t>2025/2/1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41B8608-79C2-A444-B95E-4075ABF316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54039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4303DA7-31E2-C04C-9864-763A52711A36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31568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494B7-04A3-5A45-9775-1B3A94643B8F}" type="datetimeFigureOut">
              <a:rPr kumimoji="1" lang="ja-JP" altLang="en-US" smtClean="0"/>
              <a:t>2025/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A57D9-26C4-064F-928F-A7EF747A12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90695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494B7-04A3-5A45-9775-1B3A94643B8F}" type="datetimeFigureOut">
              <a:rPr kumimoji="1" lang="ja-JP" altLang="en-US" smtClean="0"/>
              <a:t>2025/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A57D9-26C4-064F-928F-A7EF747A12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48366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494B7-04A3-5A45-9775-1B3A94643B8F}" type="datetimeFigureOut">
              <a:rPr kumimoji="1" lang="ja-JP" altLang="en-US" smtClean="0"/>
              <a:t>2025/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A57D9-26C4-064F-928F-A7EF747A12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01238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494B7-04A3-5A45-9775-1B3A94643B8F}" type="datetimeFigureOut">
              <a:rPr kumimoji="1" lang="ja-JP" altLang="en-US" smtClean="0"/>
              <a:t>2025/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A57D9-26C4-064F-928F-A7EF747A12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41355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494B7-04A3-5A45-9775-1B3A94643B8F}" type="datetimeFigureOut">
              <a:rPr kumimoji="1" lang="ja-JP" altLang="en-US" smtClean="0"/>
              <a:t>2025/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A57D9-26C4-064F-928F-A7EF747A12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73493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494B7-04A3-5A45-9775-1B3A94643B8F}" type="datetimeFigureOut">
              <a:rPr kumimoji="1" lang="ja-JP" altLang="en-US" smtClean="0"/>
              <a:t>2025/2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A57D9-26C4-064F-928F-A7EF747A12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76974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494B7-04A3-5A45-9775-1B3A94643B8F}" type="datetimeFigureOut">
              <a:rPr kumimoji="1" lang="ja-JP" altLang="en-US" smtClean="0"/>
              <a:t>2025/2/1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A57D9-26C4-064F-928F-A7EF747A12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54589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494B7-04A3-5A45-9775-1B3A94643B8F}" type="datetimeFigureOut">
              <a:rPr kumimoji="1" lang="ja-JP" altLang="en-US" smtClean="0"/>
              <a:t>2025/2/1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A57D9-26C4-064F-928F-A7EF747A12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99465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494B7-04A3-5A45-9775-1B3A94643B8F}" type="datetimeFigureOut">
              <a:rPr kumimoji="1" lang="ja-JP" altLang="en-US" smtClean="0"/>
              <a:t>2025/2/1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A57D9-26C4-064F-928F-A7EF747A12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98338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494B7-04A3-5A45-9775-1B3A94643B8F}" type="datetimeFigureOut">
              <a:rPr kumimoji="1" lang="ja-JP" altLang="en-US" smtClean="0"/>
              <a:t>2025/2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A57D9-26C4-064F-928F-A7EF747A12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14769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494B7-04A3-5A45-9775-1B3A94643B8F}" type="datetimeFigureOut">
              <a:rPr kumimoji="1" lang="ja-JP" altLang="en-US" smtClean="0"/>
              <a:t>2025/2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A57D9-26C4-064F-928F-A7EF747A12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58610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B494B7-04A3-5A45-9775-1B3A94643B8F}" type="datetimeFigureOut">
              <a:rPr kumimoji="1" lang="ja-JP" altLang="en-US" smtClean="0"/>
              <a:t>2025/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CA57D9-26C4-064F-928F-A7EF747A12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55302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B045F1D-99C3-1E4A-A307-EE3091FD39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12296" y="473870"/>
            <a:ext cx="8319407" cy="1325563"/>
          </a:xfrm>
        </p:spPr>
        <p:txBody>
          <a:bodyPr>
            <a:normAutofit/>
          </a:bodyPr>
          <a:lstStyle/>
          <a:p>
            <a:pPr algn="ctr"/>
            <a:r>
              <a:rPr lang="en-US" altLang="ja-JP" sz="3200" dirty="0">
                <a:latin typeface="Arial" panose="020B0604020202020204" pitchFamily="34" charset="0"/>
                <a:cs typeface="Arial" panose="020B0604020202020204" pitchFamily="34" charset="0"/>
              </a:rPr>
              <a:t>&lt; Laboratory Data (Admission day)&gt;</a:t>
            </a:r>
            <a:endParaRPr kumimoji="1" lang="ja-JP" altLang="en-US" sz="3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02EC3D03-20C6-684B-BB8E-B17E8B1436F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85198090"/>
              </p:ext>
            </p:extLst>
          </p:nvPr>
        </p:nvGraphicFramePr>
        <p:xfrm>
          <a:off x="644979" y="1466858"/>
          <a:ext cx="4110990" cy="520695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370330">
                  <a:extLst>
                    <a:ext uri="{9D8B030D-6E8A-4147-A177-3AD203B41FA5}">
                      <a16:colId xmlns:a16="http://schemas.microsoft.com/office/drawing/2014/main" val="3682007035"/>
                    </a:ext>
                  </a:extLst>
                </a:gridCol>
                <a:gridCol w="1199581">
                  <a:extLst>
                    <a:ext uri="{9D8B030D-6E8A-4147-A177-3AD203B41FA5}">
                      <a16:colId xmlns:a16="http://schemas.microsoft.com/office/drawing/2014/main" val="71509418"/>
                    </a:ext>
                  </a:extLst>
                </a:gridCol>
                <a:gridCol w="1541079">
                  <a:extLst>
                    <a:ext uri="{9D8B030D-6E8A-4147-A177-3AD203B41FA5}">
                      <a16:colId xmlns:a16="http://schemas.microsoft.com/office/drawing/2014/main" val="1300711205"/>
                    </a:ext>
                  </a:extLst>
                </a:gridCol>
              </a:tblGrid>
              <a:tr h="40053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BC</a:t>
                      </a:r>
                      <a:endParaRPr lang="en-US" sz="18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33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1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μ</a:t>
                      </a:r>
                      <a:r>
                        <a:rPr lang="en-US" sz="1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726330730"/>
                  </a:ext>
                </a:extLst>
              </a:tr>
              <a:tr h="40053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800" u="none" strike="noStrike" dirty="0" err="1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tro</a:t>
                      </a:r>
                      <a:r>
                        <a:rPr lang="en-US" sz="18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8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2.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</a:t>
                      </a:r>
                      <a:endParaRPr lang="en-US" altLang="ja-JP" sz="1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940018466"/>
                  </a:ext>
                </a:extLst>
              </a:tr>
              <a:tr h="40053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b="0" i="0" u="none" strike="noStrike" dirty="0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TP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.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g/</a:t>
                      </a:r>
                      <a:r>
                        <a:rPr lang="en-US" sz="1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dL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934881848"/>
                  </a:ext>
                </a:extLst>
              </a:tr>
              <a:tr h="40053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u="none" strike="noStrike" dirty="0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b</a:t>
                      </a:r>
                      <a:endParaRPr lang="en-US" sz="1800" b="0" i="0" u="none" strike="noStrike" dirty="0">
                        <a:solidFill>
                          <a:srgbClr val="0070C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.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/</a:t>
                      </a:r>
                      <a:r>
                        <a:rPr lang="en-US" sz="1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L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082572653"/>
                  </a:ext>
                </a:extLst>
              </a:tr>
              <a:tr h="40053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UN</a:t>
                      </a:r>
                      <a:endParaRPr lang="en-US" sz="18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g/</a:t>
                      </a:r>
                      <a:r>
                        <a:rPr lang="en-US" sz="1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L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841762779"/>
                  </a:ext>
                </a:extLst>
              </a:tr>
              <a:tr h="40053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E</a:t>
                      </a:r>
                      <a:endParaRPr lang="en-US" sz="18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2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g/</a:t>
                      </a:r>
                      <a:r>
                        <a:rPr lang="en-US" sz="1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L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917981863"/>
                  </a:ext>
                </a:extLst>
              </a:tr>
              <a:tr h="40053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-</a:t>
                      </a:r>
                      <a:r>
                        <a:rPr lang="en-US" sz="1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l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</a:t>
                      </a:r>
                      <a:endParaRPr lang="en-US" altLang="ja-JP" sz="1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g/</a:t>
                      </a:r>
                      <a:r>
                        <a:rPr lang="en-US" sz="1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L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24139036"/>
                  </a:ext>
                </a:extLst>
              </a:tr>
              <a:tr h="40053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T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/L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745251951"/>
                  </a:ext>
                </a:extLst>
              </a:tr>
              <a:tr h="40053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T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/L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652169739"/>
                  </a:ext>
                </a:extLst>
              </a:tr>
              <a:tr h="40053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P</a:t>
                      </a:r>
                      <a:endParaRPr lang="en-US" sz="18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1.7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g/</a:t>
                      </a:r>
                      <a:r>
                        <a:rPr lang="en-US" sz="1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L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739356017"/>
                  </a:ext>
                </a:extLst>
              </a:tr>
              <a:tr h="40053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b="0" i="0" u="none" strike="noStrike" dirty="0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Na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70C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3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mol/L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011325664"/>
                  </a:ext>
                </a:extLst>
              </a:tr>
              <a:tr h="40053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K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.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mol/L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393588828"/>
                  </a:ext>
                </a:extLst>
              </a:tr>
              <a:tr h="40053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Cl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0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mol/L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59759598"/>
                  </a:ext>
                </a:extLst>
              </a:tr>
            </a:tbl>
          </a:graphicData>
        </a:graphic>
      </p:graphicFrame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30B73D74-A1E1-6A4E-B940-B96CDA99DA7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59643416"/>
              </p:ext>
            </p:extLst>
          </p:nvPr>
        </p:nvGraphicFramePr>
        <p:xfrm>
          <a:off x="5033010" y="2459846"/>
          <a:ext cx="4110990" cy="1985976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370330">
                  <a:extLst>
                    <a:ext uri="{9D8B030D-6E8A-4147-A177-3AD203B41FA5}">
                      <a16:colId xmlns:a16="http://schemas.microsoft.com/office/drawing/2014/main" val="3090594101"/>
                    </a:ext>
                  </a:extLst>
                </a:gridCol>
                <a:gridCol w="1370330">
                  <a:extLst>
                    <a:ext uri="{9D8B030D-6E8A-4147-A177-3AD203B41FA5}">
                      <a16:colId xmlns:a16="http://schemas.microsoft.com/office/drawing/2014/main" val="3164860990"/>
                    </a:ext>
                  </a:extLst>
                </a:gridCol>
                <a:gridCol w="1370330">
                  <a:extLst>
                    <a:ext uri="{9D8B030D-6E8A-4147-A177-3AD203B41FA5}">
                      <a16:colId xmlns:a16="http://schemas.microsoft.com/office/drawing/2014/main" val="2640011411"/>
                    </a:ext>
                  </a:extLst>
                </a:gridCol>
              </a:tblGrid>
              <a:tr h="49649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APTT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6.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seconds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018764086"/>
                  </a:ext>
                </a:extLst>
              </a:tr>
              <a:tr h="49649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T%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2.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%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410784501"/>
                  </a:ext>
                </a:extLst>
              </a:tr>
              <a:tr h="49649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T-INR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722332110"/>
                  </a:ext>
                </a:extLst>
              </a:tr>
              <a:tr h="49649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b="0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D-dimer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.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μg</a:t>
                      </a:r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/ml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906387481"/>
                  </a:ext>
                </a:extLst>
              </a:tr>
            </a:tbl>
          </a:graphicData>
        </a:graphic>
      </p:graphicFrame>
      <p:graphicFrame>
        <p:nvGraphicFramePr>
          <p:cNvPr id="8" name="表 7">
            <a:extLst>
              <a:ext uri="{FF2B5EF4-FFF2-40B4-BE49-F238E27FC236}">
                <a16:creationId xmlns:a16="http://schemas.microsoft.com/office/drawing/2014/main" id="{A63C9233-4381-254D-B93A-67097C53376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08856023"/>
              </p:ext>
            </p:extLst>
          </p:nvPr>
        </p:nvGraphicFramePr>
        <p:xfrm>
          <a:off x="5033010" y="1466858"/>
          <a:ext cx="4110990" cy="992988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370330">
                  <a:extLst>
                    <a:ext uri="{9D8B030D-6E8A-4147-A177-3AD203B41FA5}">
                      <a16:colId xmlns:a16="http://schemas.microsoft.com/office/drawing/2014/main" val="3090594101"/>
                    </a:ext>
                  </a:extLst>
                </a:gridCol>
                <a:gridCol w="1370330">
                  <a:extLst>
                    <a:ext uri="{9D8B030D-6E8A-4147-A177-3AD203B41FA5}">
                      <a16:colId xmlns:a16="http://schemas.microsoft.com/office/drawing/2014/main" val="3164860990"/>
                    </a:ext>
                  </a:extLst>
                </a:gridCol>
                <a:gridCol w="1370330">
                  <a:extLst>
                    <a:ext uri="{9D8B030D-6E8A-4147-A177-3AD203B41FA5}">
                      <a16:colId xmlns:a16="http://schemas.microsoft.com/office/drawing/2014/main" val="2640011411"/>
                    </a:ext>
                  </a:extLst>
                </a:gridCol>
              </a:tblGrid>
              <a:tr h="49649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Glu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g/</a:t>
                      </a:r>
                      <a:r>
                        <a:rPr lang="en-US" sz="1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dL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018764086"/>
                  </a:ext>
                </a:extLst>
              </a:tr>
              <a:tr h="49649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b="0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HbA1c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0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.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%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410784501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2CFC254D-C5DD-E45D-BFCE-E37D4EC33780}"/>
              </a:ext>
            </a:extLst>
          </p:cNvPr>
          <p:cNvSpPr txBox="1"/>
          <p:nvPr/>
        </p:nvSpPr>
        <p:spPr>
          <a:xfrm>
            <a:off x="310243" y="277585"/>
            <a:ext cx="27649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ure. 1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498764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98</Words>
  <Application>Microsoft Macintosh PowerPoint</Application>
  <PresentationFormat>画面に合わせる (4:3)</PresentationFormat>
  <Paragraphs>59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&lt; Laboratory Data (Admission day)&gt;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伯潔</dc:creator>
  <cp:lastModifiedBy>佐伯 潔</cp:lastModifiedBy>
  <cp:revision>6</cp:revision>
  <dcterms:created xsi:type="dcterms:W3CDTF">2025-01-13T03:32:45Z</dcterms:created>
  <dcterms:modified xsi:type="dcterms:W3CDTF">2025-02-11T00:39:38Z</dcterms:modified>
</cp:coreProperties>
</file>